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60" r:id="rId2"/>
    <p:sldId id="265" r:id="rId3"/>
    <p:sldId id="264" r:id="rId4"/>
    <p:sldId id="266" r:id="rId5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D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97" d="100"/>
          <a:sy n="97" d="100"/>
        </p:scale>
        <p:origin x="384" y="7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14/10/2021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60027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73729302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3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76506667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4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6994087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4/10/2021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4/10/2021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4/10/2021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4/10/2021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4/10/2021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4/10/2021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4/10/2021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4/10/2021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4/10/2021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4/10/2021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4/10/2021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14/10/2021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hyperlink" Target="http://creativecommons.org/licenses/by/4.0/" TargetMode="External"/><Relationship Id="rId4" Type="http://schemas.openxmlformats.org/officeDocument/2006/relationships/image" Target="../media/image2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.png"/><Relationship Id="rId4" Type="http://schemas.openxmlformats.org/officeDocument/2006/relationships/hyperlink" Target="http://creativecommons.org/licenses/by/4.0/" TargetMode="Externa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Relationship Id="rId5" Type="http://schemas.openxmlformats.org/officeDocument/2006/relationships/hyperlink" Target="http://creativecommons.org/licenses/by/4.0/" TargetMode="External"/><Relationship Id="rId4" Type="http://schemas.openxmlformats.org/officeDocument/2006/relationships/image" Target="../media/image2.tif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5.png"/><Relationship Id="rId4" Type="http://schemas.openxmlformats.org/officeDocument/2006/relationships/hyperlink" Target="http://creativecommons.org/licenses/by/4.0/" TargetMode="Externa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6E3E971F-4AD9-4D23-8282-C7FA1C34734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30302" y="1124744"/>
            <a:ext cx="8493303" cy="4411482"/>
          </a:xfrm>
          <a:prstGeom prst="rect">
            <a:avLst/>
          </a:prstGeom>
        </p:spPr>
      </p:pic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4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320395" y="5462408"/>
            <a:ext cx="799288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en-GB" dirty="0"/>
              <a:t>Agyemang et al (2021) Diabetologia DOI 10.1007/s00125-021-05586-1 </a:t>
            </a:r>
          </a:p>
          <a:p>
            <a:r>
              <a:rPr lang="en-GB" sz="1200" dirty="0"/>
              <a:t>© The Authors 2021. Distributed under the terms of the CC BY 4.0 Attribution License (</a:t>
            </a:r>
            <a:r>
              <a:rPr lang="en-GB" sz="1200" dirty="0">
                <a:hlinkClick r:id="rId5"/>
              </a:rPr>
              <a:t>http://creativecommons.org/licenses/by/4.0/</a:t>
            </a:r>
            <a:r>
              <a:rPr lang="en-GB" sz="1200" dirty="0"/>
              <a:t>)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95536" y="519613"/>
            <a:ext cx="871296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Type 2 diabetes in ethnic minorities in Europe</a:t>
            </a:r>
          </a:p>
        </p:txBody>
      </p:sp>
    </p:spTree>
    <p:extLst>
      <p:ext uri="{BB962C8B-B14F-4D97-AF65-F5344CB8AC3E}">
        <p14:creationId xmlns:p14="http://schemas.microsoft.com/office/powerpoint/2010/main" val="25235991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320395" y="5462408"/>
            <a:ext cx="799288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en-GB" dirty="0"/>
              <a:t>Agyemang et al (2021) Diabetologia DOI 10.1007/s00125-021-05586-1 </a:t>
            </a:r>
          </a:p>
          <a:p>
            <a:r>
              <a:rPr lang="en-GB" sz="1200" dirty="0"/>
              <a:t>© The Authors 2021. Distributed under the terms of the CC BY 4.0 Attribution License (</a:t>
            </a:r>
            <a:r>
              <a:rPr lang="en-GB" sz="1200" dirty="0">
                <a:hlinkClick r:id="rId4"/>
              </a:rPr>
              <a:t>http://creativecommons.org/licenses/by/4.0/</a:t>
            </a:r>
            <a:r>
              <a:rPr lang="en-GB" sz="1200" dirty="0"/>
              <a:t>)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95536" y="519613"/>
            <a:ext cx="8712968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Prevalence of prediabetes and type 2 diabetes in the MEDIM cohort, showing data for Middle Eastern migrants and the host European population of Swedes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EC19EEB4-E931-493F-A745-8B32556D407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79512" y="1326754"/>
            <a:ext cx="8462109" cy="410557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2096371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F3360550-959E-45A7-8B4F-D5A887E8F98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67544" y="1481162"/>
            <a:ext cx="7737932" cy="3819204"/>
          </a:xfrm>
          <a:prstGeom prst="rect">
            <a:avLst/>
          </a:prstGeom>
        </p:spPr>
      </p:pic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4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320395" y="5462408"/>
            <a:ext cx="799288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en-GB" dirty="0"/>
              <a:t>Agyemang et al (2021) Diabetologia DOI 10.1007/s00125-021-05586-1 </a:t>
            </a:r>
          </a:p>
          <a:p>
            <a:r>
              <a:rPr lang="en-GB" sz="1200" dirty="0"/>
              <a:t>© The Authors 2021. Distributed under the terms of the CC BY 4.0 Attribution License (</a:t>
            </a:r>
            <a:r>
              <a:rPr lang="en-GB" sz="1200" dirty="0">
                <a:hlinkClick r:id="rId5"/>
              </a:rPr>
              <a:t>http://creativecommons.org/licenses/by/4.0/</a:t>
            </a:r>
            <a:r>
              <a:rPr lang="en-GB" sz="1200" dirty="0"/>
              <a:t>)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95536" y="519613"/>
            <a:ext cx="8712968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Mortality rate ratios (MRRs) and 95% CIs in diabetes-related mortality among migrant groups compared with Europeans in six European countries </a:t>
            </a:r>
          </a:p>
        </p:txBody>
      </p:sp>
    </p:spTree>
    <p:extLst>
      <p:ext uri="{BB962C8B-B14F-4D97-AF65-F5344CB8AC3E}">
        <p14:creationId xmlns:p14="http://schemas.microsoft.com/office/powerpoint/2010/main" val="276785972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320395" y="5462408"/>
            <a:ext cx="799288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en-GB" dirty="0"/>
              <a:t>Agyemang et al (2021) Diabetologia DOI 10.1007/s00125-021-05586-1 </a:t>
            </a:r>
          </a:p>
          <a:p>
            <a:r>
              <a:rPr lang="en-GB" sz="1200" dirty="0"/>
              <a:t>© The Authors 2021. Distributed under the terms of the CC BY 4.0 Attribution License (</a:t>
            </a:r>
            <a:r>
              <a:rPr lang="en-GB" sz="1200" dirty="0">
                <a:hlinkClick r:id="rId4"/>
              </a:rPr>
              <a:t>http://creativecommons.org/licenses/by/4.0/</a:t>
            </a:r>
            <a:r>
              <a:rPr lang="en-GB" sz="1200" dirty="0"/>
              <a:t>)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95536" y="519613"/>
            <a:ext cx="871296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Pathways leading to the high risk of type 2 diabetes in migrants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A9073487-585B-442D-B319-76B5E54EA73B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758917" y="933924"/>
            <a:ext cx="5626165" cy="476383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51757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85</TotalTime>
  <Words>232</Words>
  <Application>Microsoft Office PowerPoint</Application>
  <PresentationFormat>On-screen Show (4:3)</PresentationFormat>
  <Paragraphs>20</Paragraphs>
  <Slides>4</Slides>
  <Notes>4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7" baseType="lpstr">
      <vt:lpstr>Arial</vt:lpstr>
      <vt:lpstr>Calibri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Madeleine Stimpson</cp:lastModifiedBy>
  <cp:revision>39</cp:revision>
  <dcterms:created xsi:type="dcterms:W3CDTF">2016-06-15T12:53:43Z</dcterms:created>
  <dcterms:modified xsi:type="dcterms:W3CDTF">2021-10-14T14:51:41Z</dcterms:modified>
</cp:coreProperties>
</file>